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 varScale="1">
        <p:scale>
          <a:sx n="62" d="100"/>
          <a:sy n="62" d="100"/>
        </p:scale>
        <p:origin x="3024" y="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B4BA1-BC5E-4F3D-816A-A76A79A4149A}" type="datetimeFigureOut">
              <a:rPr lang="en-US" smtClean="0"/>
              <a:pPr/>
              <a:t>4/1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4BA9A-EC34-42EC-BA8A-EC9D3F9A8BD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4887384" y="-644217"/>
            <a:ext cx="38594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sp>
        <p:nvSpPr>
          <p:cNvPr id="11" name="TextBox 12"/>
          <p:cNvSpPr txBox="1"/>
          <p:nvPr/>
        </p:nvSpPr>
        <p:spPr>
          <a:xfrm>
            <a:off x="4348980" y="8805446"/>
            <a:ext cx="25090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Arial" pitchFamily="34" charset="0"/>
                <a:cs typeface="Arial" pitchFamily="34" charset="0"/>
              </a:rPr>
              <a:t>Supplementary Figure S4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8F41890E-CAC4-4C4A-BDB8-50489EA87E54}"/>
              </a:ext>
            </a:extLst>
          </p:cNvPr>
          <p:cNvGrpSpPr/>
          <p:nvPr/>
        </p:nvGrpSpPr>
        <p:grpSpPr>
          <a:xfrm>
            <a:off x="242404" y="1105579"/>
            <a:ext cx="4023318" cy="3139440"/>
            <a:chOff x="1417341" y="208112"/>
            <a:chExt cx="4023318" cy="3139440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2" cstate="print"/>
            <a:srcRect l="21177" t="8000" r="22353" b="33329"/>
            <a:stretch/>
          </p:blipFill>
          <p:spPr>
            <a:xfrm>
              <a:off x="1417341" y="208112"/>
              <a:ext cx="4023318" cy="2458888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39CAFE96-67E4-420D-9665-4D27C5771A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/>
            <a:srcRect l="31204" t="75761" r="31363" b="8001"/>
            <a:stretch/>
          </p:blipFill>
          <p:spPr>
            <a:xfrm>
              <a:off x="2133600" y="2667000"/>
              <a:ext cx="2667000" cy="680552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F201C51-49E9-43D8-AFEF-1EA107A55EC8}"/>
              </a:ext>
            </a:extLst>
          </p:cNvPr>
          <p:cNvSpPr txBox="1"/>
          <p:nvPr/>
        </p:nvSpPr>
        <p:spPr>
          <a:xfrm>
            <a:off x="38662" y="425027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2114B1E-094D-4C1D-B069-2BAC70A3CF46}"/>
              </a:ext>
            </a:extLst>
          </p:cNvPr>
          <p:cNvSpPr txBox="1"/>
          <p:nvPr/>
        </p:nvSpPr>
        <p:spPr>
          <a:xfrm>
            <a:off x="4038600" y="425027"/>
            <a:ext cx="5774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2D9E0A7-05F9-4CE7-AA9E-C569D1C561E1}"/>
              </a:ext>
            </a:extLst>
          </p:cNvPr>
          <p:cNvSpPr txBox="1"/>
          <p:nvPr/>
        </p:nvSpPr>
        <p:spPr>
          <a:xfrm>
            <a:off x="38662" y="5029200"/>
            <a:ext cx="5613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5E06027-8D55-4CDE-9139-15F3277F5D10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207080830"/>
              </p:ext>
            </p:extLst>
          </p:nvPr>
        </p:nvGraphicFramePr>
        <p:xfrm>
          <a:off x="4617720" y="234696"/>
          <a:ext cx="2011680" cy="48646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5840">
                  <a:extLst>
                    <a:ext uri="{9D8B030D-6E8A-4147-A177-3AD203B41FA5}">
                      <a16:colId xmlns:a16="http://schemas.microsoft.com/office/drawing/2014/main" val="609777202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892861114"/>
                    </a:ext>
                  </a:extLst>
                </a:gridCol>
              </a:tblGrid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3120987769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pep</a:t>
                      </a:r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3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5038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2654792213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x2 (F11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0948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503584498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df15 (C1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434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2184061637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t5e (E8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291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598868556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cam</a:t>
                      </a:r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2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625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3264837580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2 (E4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461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2470447314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cam1 (G7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543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3968931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10 (B8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569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2484151566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ch1 (E7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553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748580966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f1 (C12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92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3035360412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s</a:t>
                      </a:r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E5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747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3466758435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arg</a:t>
                      </a:r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F1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014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3365450985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gf2 (B9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517</a:t>
                      </a:r>
                      <a:endParaRPr lang="en-US" sz="1100" b="1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1899815401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gfa</a:t>
                      </a:r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G8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124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1002283342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fb3 (G4)</a:t>
                      </a:r>
                      <a:endParaRPr lang="en-US" sz="11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7663</a:t>
                      </a:r>
                      <a:endParaRPr lang="en-US" sz="1100" b="1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3409670146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tl (D12)</a:t>
                      </a:r>
                      <a:endParaRPr lang="en-US" sz="1100" b="1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2892</a:t>
                      </a:r>
                      <a:endParaRPr lang="en-US" sz="1100" b="1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2504364045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f</a:t>
                      </a:r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C8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.2472</a:t>
                      </a:r>
                      <a:endParaRPr lang="en-US" sz="1100" b="1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718768098"/>
                  </a:ext>
                </a:extLst>
              </a:tr>
              <a:tr h="25603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p4 (A8)</a:t>
                      </a:r>
                      <a:endParaRPr lang="en-US" sz="1100" b="1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1" u="none" strike="noStrike" dirty="0">
                          <a:solidFill>
                            <a:srgbClr val="00B05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3.3647</a:t>
                      </a:r>
                      <a:endParaRPr lang="en-US" sz="1100" b="1" i="0" u="none" strike="noStrike" dirty="0">
                        <a:solidFill>
                          <a:srgbClr val="00B05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395" marR="7395" marT="7395" marB="0" anchor="ctr"/>
                </a:tc>
                <a:extLst>
                  <a:ext uri="{0D108BD9-81ED-4DB2-BD59-A6C34878D82A}">
                    <a16:rowId xmlns:a16="http://schemas.microsoft.com/office/drawing/2014/main" val="1816328532"/>
                  </a:ext>
                </a:extLst>
              </a:tr>
            </a:tbl>
          </a:graphicData>
        </a:graphic>
      </p:graphicFrame>
      <p:grpSp>
        <p:nvGrpSpPr>
          <p:cNvPr id="54" name="Group 53">
            <a:extLst>
              <a:ext uri="{FF2B5EF4-FFF2-40B4-BE49-F238E27FC236}">
                <a16:creationId xmlns:a16="http://schemas.microsoft.com/office/drawing/2014/main" id="{8666C753-3911-4AE3-93C7-6B7209EA793F}"/>
              </a:ext>
            </a:extLst>
          </p:cNvPr>
          <p:cNvGrpSpPr/>
          <p:nvPr/>
        </p:nvGrpSpPr>
        <p:grpSpPr>
          <a:xfrm>
            <a:off x="650364" y="8001000"/>
            <a:ext cx="4375790" cy="403126"/>
            <a:chOff x="650364" y="8159222"/>
            <a:chExt cx="4375790" cy="403126"/>
          </a:xfrm>
        </p:grpSpPr>
        <p:pic>
          <p:nvPicPr>
            <p:cNvPr id="21" name="Picture 20" descr="GAPDH.jpg">
              <a:extLst>
                <a:ext uri="{FF2B5EF4-FFF2-40B4-BE49-F238E27FC236}">
                  <a16:creationId xmlns:a16="http://schemas.microsoft.com/office/drawing/2014/main" id="{7A64B240-5BB4-4F2C-8424-E6DE9B2DEFCB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100000"/>
                      </a14:imgEffect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3" r="754"/>
            <a:stretch/>
          </p:blipFill>
          <p:spPr>
            <a:xfrm>
              <a:off x="1481330" y="8159222"/>
              <a:ext cx="3544824" cy="403126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BDDD3AE-2DFC-487C-A893-5C181914B56C}"/>
                </a:ext>
              </a:extLst>
            </p:cNvPr>
            <p:cNvSpPr txBox="1"/>
            <p:nvPr/>
          </p:nvSpPr>
          <p:spPr>
            <a:xfrm>
              <a:off x="650364" y="8206897"/>
              <a:ext cx="8242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827C2FAB-C68B-4F73-82ED-E349224E6208}"/>
              </a:ext>
            </a:extLst>
          </p:cNvPr>
          <p:cNvGrpSpPr/>
          <p:nvPr/>
        </p:nvGrpSpPr>
        <p:grpSpPr>
          <a:xfrm>
            <a:off x="1039895" y="6613010"/>
            <a:ext cx="3986259" cy="377585"/>
            <a:chOff x="1039895" y="6589653"/>
            <a:chExt cx="3986259" cy="377585"/>
          </a:xfrm>
        </p:grpSpPr>
        <p:pic>
          <p:nvPicPr>
            <p:cNvPr id="23" name="Picture 22" descr="scf1.jpg">
              <a:extLst>
                <a:ext uri="{FF2B5EF4-FFF2-40B4-BE49-F238E27FC236}">
                  <a16:creationId xmlns:a16="http://schemas.microsoft.com/office/drawing/2014/main" id="{887D65FA-A35E-42A1-BB31-F048EADC40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9" r="1414"/>
            <a:stretch/>
          </p:blipFill>
          <p:spPr>
            <a:xfrm>
              <a:off x="1474629" y="6589653"/>
              <a:ext cx="3551525" cy="377585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731C566-FD8F-46E8-9621-13BC89A0BE53}"/>
                </a:ext>
              </a:extLst>
            </p:cNvPr>
            <p:cNvSpPr txBox="1"/>
            <p:nvPr/>
          </p:nvSpPr>
          <p:spPr>
            <a:xfrm>
              <a:off x="1039895" y="6624557"/>
              <a:ext cx="4347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Kitl</a:t>
              </a:r>
              <a:endParaRPr 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86EC6818-8C66-421E-A838-59DC1109FAF6}"/>
              </a:ext>
            </a:extLst>
          </p:cNvPr>
          <p:cNvGrpSpPr/>
          <p:nvPr/>
        </p:nvGrpSpPr>
        <p:grpSpPr>
          <a:xfrm>
            <a:off x="821886" y="7529370"/>
            <a:ext cx="4204268" cy="358334"/>
            <a:chOff x="821886" y="7651877"/>
            <a:chExt cx="4204268" cy="358334"/>
          </a:xfrm>
        </p:grpSpPr>
        <p:pic>
          <p:nvPicPr>
            <p:cNvPr id="25" name="Picture 24" descr="BMP4.jpg">
              <a:extLst>
                <a:ext uri="{FF2B5EF4-FFF2-40B4-BE49-F238E27FC236}">
                  <a16:creationId xmlns:a16="http://schemas.microsoft.com/office/drawing/2014/main" id="{3307470A-9E39-4891-808A-EA78431FED9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9" r="2091"/>
            <a:stretch/>
          </p:blipFill>
          <p:spPr>
            <a:xfrm>
              <a:off x="1481330" y="7651877"/>
              <a:ext cx="3544824" cy="358334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0DDDC7C-E5E3-40CF-98D9-7E9BFA0AB8F1}"/>
                </a:ext>
              </a:extLst>
            </p:cNvPr>
            <p:cNvSpPr txBox="1"/>
            <p:nvPr/>
          </p:nvSpPr>
          <p:spPr>
            <a:xfrm>
              <a:off x="821886" y="7677156"/>
              <a:ext cx="6527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Bmp4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8B26F7B4-8CF4-4B9B-ACAC-BCB5EA20DCC7}"/>
              </a:ext>
            </a:extLst>
          </p:cNvPr>
          <p:cNvGrpSpPr/>
          <p:nvPr/>
        </p:nvGrpSpPr>
        <p:grpSpPr>
          <a:xfrm>
            <a:off x="1011041" y="7103890"/>
            <a:ext cx="4018159" cy="312185"/>
            <a:chOff x="1011041" y="7166910"/>
            <a:chExt cx="4018159" cy="312185"/>
          </a:xfrm>
        </p:grpSpPr>
        <p:pic>
          <p:nvPicPr>
            <p:cNvPr id="24" name="Picture 23" descr="HGF.jpg">
              <a:extLst>
                <a:ext uri="{FF2B5EF4-FFF2-40B4-BE49-F238E27FC236}">
                  <a16:creationId xmlns:a16="http://schemas.microsoft.com/office/drawing/2014/main" id="{7A5B104A-75AB-4AE4-808D-C2E3572B402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4" r="1"/>
            <a:stretch/>
          </p:blipFill>
          <p:spPr>
            <a:xfrm>
              <a:off x="1481328" y="7166910"/>
              <a:ext cx="3547872" cy="312185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E49059E-E84C-4E59-853C-DB810C818767}"/>
                </a:ext>
              </a:extLst>
            </p:cNvPr>
            <p:cNvSpPr txBox="1"/>
            <p:nvPr/>
          </p:nvSpPr>
          <p:spPr>
            <a:xfrm>
              <a:off x="1011041" y="7169114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Hgf</a:t>
              </a:r>
              <a:endParaRPr 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2279DD3A-6E53-4A2F-A635-472F08AB0A51}"/>
              </a:ext>
            </a:extLst>
          </p:cNvPr>
          <p:cNvGrpSpPr/>
          <p:nvPr/>
        </p:nvGrpSpPr>
        <p:grpSpPr>
          <a:xfrm>
            <a:off x="831761" y="6170363"/>
            <a:ext cx="4194394" cy="329351"/>
            <a:chOff x="831761" y="6170363"/>
            <a:chExt cx="4194394" cy="329351"/>
          </a:xfrm>
        </p:grpSpPr>
        <p:pic>
          <p:nvPicPr>
            <p:cNvPr id="37" name="Picture 36" descr="vegfa.jpg">
              <a:extLst>
                <a:ext uri="{FF2B5EF4-FFF2-40B4-BE49-F238E27FC236}">
                  <a16:creationId xmlns:a16="http://schemas.microsoft.com/office/drawing/2014/main" id="{B13263EE-C666-4296-82D2-480652F8AE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8" t="18720" r="460"/>
            <a:stretch/>
          </p:blipFill>
          <p:spPr>
            <a:xfrm>
              <a:off x="1481331" y="6170363"/>
              <a:ext cx="3544824" cy="329351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E3D55F0-C9FC-4844-B693-20986656BF71}"/>
                </a:ext>
              </a:extLst>
            </p:cNvPr>
            <p:cNvSpPr txBox="1"/>
            <p:nvPr/>
          </p:nvSpPr>
          <p:spPr>
            <a:xfrm>
              <a:off x="831761" y="6181150"/>
              <a:ext cx="6428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Vegfa</a:t>
              </a:r>
              <a:endParaRPr 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271321DB-4C8A-441A-BB2E-40B3D9B1B9A3}"/>
              </a:ext>
            </a:extLst>
          </p:cNvPr>
          <p:cNvSpPr txBox="1"/>
          <p:nvPr/>
        </p:nvSpPr>
        <p:spPr>
          <a:xfrm>
            <a:off x="353809" y="5790458"/>
            <a:ext cx="1120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x (2% O</a:t>
            </a:r>
            <a:r>
              <a:rPr lang="en-US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E002B900-D293-4814-A1A4-E685A1A143DE}"/>
              </a:ext>
            </a:extLst>
          </p:cNvPr>
          <p:cNvGrpSpPr/>
          <p:nvPr/>
        </p:nvGrpSpPr>
        <p:grpSpPr>
          <a:xfrm>
            <a:off x="1586654" y="5790458"/>
            <a:ext cx="3406050" cy="307777"/>
            <a:chOff x="1994845" y="5901716"/>
            <a:chExt cx="3406050" cy="307777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3AF4EC99-07B2-498D-87DE-4D8A5BFE3C0E}"/>
                </a:ext>
              </a:extLst>
            </p:cNvPr>
            <p:cNvSpPr txBox="1"/>
            <p:nvPr/>
          </p:nvSpPr>
          <p:spPr>
            <a:xfrm>
              <a:off x="1994845" y="590171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6B6A204-3DD4-4428-AD29-08A5E44A17CC}"/>
                </a:ext>
              </a:extLst>
            </p:cNvPr>
            <p:cNvSpPr txBox="1"/>
            <p:nvPr/>
          </p:nvSpPr>
          <p:spPr>
            <a:xfrm>
              <a:off x="3727775" y="5901716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B9EE039-AF5D-4682-98EF-88965D238CF7}"/>
                </a:ext>
              </a:extLst>
            </p:cNvPr>
            <p:cNvSpPr txBox="1"/>
            <p:nvPr/>
          </p:nvSpPr>
          <p:spPr>
            <a:xfrm>
              <a:off x="4096512" y="590171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95624128-E436-433C-93C0-76DE5C09CFAE}"/>
                </a:ext>
              </a:extLst>
            </p:cNvPr>
            <p:cNvSpPr txBox="1"/>
            <p:nvPr/>
          </p:nvSpPr>
          <p:spPr>
            <a:xfrm>
              <a:off x="2359762" y="590171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50E41D0C-B275-4796-9EF3-3092906BD006}"/>
                </a:ext>
              </a:extLst>
            </p:cNvPr>
            <p:cNvSpPr txBox="1"/>
            <p:nvPr/>
          </p:nvSpPr>
          <p:spPr>
            <a:xfrm>
              <a:off x="4535424" y="590171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8h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CDE8B78-17D5-4CF2-9C93-C9AF974AB773}"/>
                </a:ext>
              </a:extLst>
            </p:cNvPr>
            <p:cNvSpPr txBox="1"/>
            <p:nvPr/>
          </p:nvSpPr>
          <p:spPr>
            <a:xfrm>
              <a:off x="2798064" y="5901716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8h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A7FE5D5-3605-425F-986B-F80794834B8C}"/>
                </a:ext>
              </a:extLst>
            </p:cNvPr>
            <p:cNvSpPr txBox="1"/>
            <p:nvPr/>
          </p:nvSpPr>
          <p:spPr>
            <a:xfrm>
              <a:off x="3185138" y="5901716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B2790F9-90BA-4D75-B47E-77F70BB2D2D9}"/>
                </a:ext>
              </a:extLst>
            </p:cNvPr>
            <p:cNvSpPr txBox="1"/>
            <p:nvPr/>
          </p:nvSpPr>
          <p:spPr>
            <a:xfrm>
              <a:off x="4918071" y="5901716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43BEAF9-FE33-43A6-BE9E-C21F733353D1}"/>
              </a:ext>
            </a:extLst>
          </p:cNvPr>
          <p:cNvGrpSpPr/>
          <p:nvPr/>
        </p:nvGrpSpPr>
        <p:grpSpPr>
          <a:xfrm>
            <a:off x="1510353" y="5407223"/>
            <a:ext cx="1645920" cy="307777"/>
            <a:chOff x="1918544" y="5407223"/>
            <a:chExt cx="1645920" cy="307777"/>
          </a:xfrm>
        </p:grpSpPr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354EB7A6-D15B-4C46-A326-4E8B1F21721A}"/>
                </a:ext>
              </a:extLst>
            </p:cNvPr>
            <p:cNvSpPr txBox="1"/>
            <p:nvPr/>
          </p:nvSpPr>
          <p:spPr>
            <a:xfrm>
              <a:off x="2509710" y="5407223"/>
              <a:ext cx="4635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FF764945-D7EB-4B4A-92EB-44A2E62E0908}"/>
                </a:ext>
              </a:extLst>
            </p:cNvPr>
            <p:cNvCxnSpPr/>
            <p:nvPr/>
          </p:nvCxnSpPr>
          <p:spPr>
            <a:xfrm>
              <a:off x="1918544" y="5715000"/>
              <a:ext cx="16459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2589ACF7-8A43-43E8-91B7-90430A755DA6}"/>
              </a:ext>
            </a:extLst>
          </p:cNvPr>
          <p:cNvGrpSpPr/>
          <p:nvPr/>
        </p:nvGrpSpPr>
        <p:grpSpPr>
          <a:xfrm>
            <a:off x="3259771" y="5407223"/>
            <a:ext cx="1645920" cy="307777"/>
            <a:chOff x="3667962" y="5407223"/>
            <a:chExt cx="1645920" cy="307777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A981A3A-13A2-4E46-91E8-C02212F62642}"/>
                </a:ext>
              </a:extLst>
            </p:cNvPr>
            <p:cNvSpPr txBox="1"/>
            <p:nvPr/>
          </p:nvSpPr>
          <p:spPr>
            <a:xfrm>
              <a:off x="3954557" y="5407223"/>
              <a:ext cx="10727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SHIP-1 KO</a:t>
              </a: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B82332D7-C8F3-44C0-9B53-F97BD76038DD}"/>
                </a:ext>
              </a:extLst>
            </p:cNvPr>
            <p:cNvCxnSpPr/>
            <p:nvPr/>
          </p:nvCxnSpPr>
          <p:spPr>
            <a:xfrm>
              <a:off x="3667962" y="5715000"/>
              <a:ext cx="16459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35954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131</Words>
  <Application>Microsoft Office PowerPoint</Application>
  <PresentationFormat>On-screen Show (4:3)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linDell</dc:creator>
  <cp:lastModifiedBy>Olin Liang</cp:lastModifiedBy>
  <cp:revision>34</cp:revision>
  <cp:lastPrinted>2019-04-16T16:37:17Z</cp:lastPrinted>
  <dcterms:created xsi:type="dcterms:W3CDTF">2016-07-07T23:34:39Z</dcterms:created>
  <dcterms:modified xsi:type="dcterms:W3CDTF">2019-04-16T17:24:02Z</dcterms:modified>
</cp:coreProperties>
</file>